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560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13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8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94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37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47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28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23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32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22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8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80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5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/>
        </p:nvGraphicFramePr>
        <p:xfrm>
          <a:off x="1260021" y="788857"/>
          <a:ext cx="4306206" cy="6066816"/>
        </p:xfrm>
        <a:graphic>
          <a:graphicData uri="http://schemas.openxmlformats.org/drawingml/2006/table">
            <a:tbl>
              <a:tblPr/>
              <a:tblGrid>
                <a:gridCol w="1414863"/>
                <a:gridCol w="755285"/>
                <a:gridCol w="923701"/>
                <a:gridCol w="1212357"/>
              </a:tblGrid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val 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DR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g2 fold 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61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6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306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9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67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1.0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4b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9b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676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6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8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225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9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8a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31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95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66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50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1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08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76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0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25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9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35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6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7b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42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48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1.4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85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9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4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0e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0-3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77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1a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127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48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12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9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21-5p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2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588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09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40</a:t>
                      </a:r>
                    </a:p>
                  </a:txBody>
                  <a:tcPr marL="6708" marR="6708" marT="67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CasellaDiTesto 9"/>
          <p:cNvSpPr txBox="1"/>
          <p:nvPr/>
        </p:nvSpPr>
        <p:spPr>
          <a:xfrm>
            <a:off x="-23905" y="-64964"/>
            <a:ext cx="1854200" cy="283941"/>
          </a:xfrm>
          <a:prstGeom prst="rect">
            <a:avLst/>
          </a:prstGeom>
          <a:noFill/>
        </p:spPr>
        <p:txBody>
          <a:bodyPr wrap="square" lIns="91428" tIns="45714" rIns="91428" bIns="45714" rtlCol="0">
            <a:spAutoFit/>
          </a:bodyPr>
          <a:lstStyle/>
          <a:p>
            <a:r>
              <a:rPr lang="en-US" sz="1200" b="1" dirty="0" smtClean="0"/>
              <a:t>Figure S5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48124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5</Words>
  <Application>Microsoft Office PowerPoint</Application>
  <PresentationFormat>On-screen Show (4:3)</PresentationFormat>
  <Paragraphs>1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f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donzelli</dc:creator>
  <cp:lastModifiedBy>Balindan, Danica Joy</cp:lastModifiedBy>
  <cp:revision>10</cp:revision>
  <dcterms:created xsi:type="dcterms:W3CDTF">2017-05-19T15:04:48Z</dcterms:created>
  <dcterms:modified xsi:type="dcterms:W3CDTF">2017-05-31T01:10:46Z</dcterms:modified>
</cp:coreProperties>
</file>